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media/image7.jpeg" ContentType="image/jpeg"/>
  <Override PartName="/ppt/media/image8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6858000" cy="9144000"/>
  <p:notesSz cx="6792913" cy="99075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E4A812-8605-4C13-BE59-8BD82B7FE96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E89BD8-7076-46E0-AC4F-DCF86BC54B5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C4D158-7173-49B1-B8DD-0FB9009E04B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757F59-AB84-4F59-83F9-7F6796F72B0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C91B52-9405-4EEB-994D-8D33C0143A2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1FA61C-831C-47AE-AFDC-5820B08921F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3D74F4-2266-4DD8-8DB2-851FF513256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B8AC35-3298-4969-97EE-63E30F0DA08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ED266E-81DB-4F45-92A1-026BC8967F7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262B28-DB44-49F4-92BD-8BF95D6D2A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FD2CF2-1085-4BE4-AC99-DA56A3EC31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33296B-AF9C-4498-99E6-2D5CF64223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E781B48-E981-4D69-993E-E1679ED9B7E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slideLayout" Target="../slideLayouts/slideLayout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image" Target="../media/image4.jpeg"/><Relationship Id="rId3" Type="http://schemas.openxmlformats.org/officeDocument/2006/relationships/image" Target="../media/image5.jpeg"/><Relationship Id="rId4" Type="http://schemas.openxmlformats.org/officeDocument/2006/relationships/image" Target="../media/image6.jpeg"/><Relationship Id="rId5" Type="http://schemas.openxmlformats.org/officeDocument/2006/relationships/image" Target="../media/image7.jpeg"/><Relationship Id="rId6" Type="http://schemas.openxmlformats.org/officeDocument/2006/relationships/image" Target="../media/image7.jpeg"/><Relationship Id="rId7" Type="http://schemas.openxmlformats.org/officeDocument/2006/relationships/image" Target="../media/image7.jpeg"/><Relationship Id="rId8" Type="http://schemas.openxmlformats.org/officeDocument/2006/relationships/image" Target="../media/image7.jpeg"/><Relationship Id="rId9" Type="http://schemas.openxmlformats.org/officeDocument/2006/relationships/image" Target="../media/image7.jpeg"/><Relationship Id="rId10" Type="http://schemas.openxmlformats.org/officeDocument/2006/relationships/image" Target="../media/image7.jpeg"/><Relationship Id="rId11" Type="http://schemas.openxmlformats.org/officeDocument/2006/relationships/image" Target="../media/image7.jpeg"/><Relationship Id="rId12" Type="http://schemas.openxmlformats.org/officeDocument/2006/relationships/image" Target="../media/image7.jpeg"/><Relationship Id="rId13" Type="http://schemas.openxmlformats.org/officeDocument/2006/relationships/slideLayout" Target="../slideLayouts/slideLayout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8.wmf"/><Relationship Id="rId2" Type="http://schemas.openxmlformats.org/officeDocument/2006/relationships/image" Target="../media/image8.wmf"/><Relationship Id="rId3" Type="http://schemas.openxmlformats.org/officeDocument/2006/relationships/image" Target="../media/image8.wmf"/><Relationship Id="rId4" Type="http://schemas.openxmlformats.org/officeDocument/2006/relationships/image" Target="../media/image8.wmf"/><Relationship Id="rId5" Type="http://schemas.openxmlformats.org/officeDocument/2006/relationships/image" Target="../media/image8.wmf"/><Relationship Id="rId6" Type="http://schemas.openxmlformats.org/officeDocument/2006/relationships/image" Target="../media/image8.wmf"/><Relationship Id="rId7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406440" y="179280"/>
            <a:ext cx="6095880" cy="8382240"/>
            <a:chOff x="406440" y="179280"/>
            <a:chExt cx="6095880" cy="8382240"/>
          </a:xfrm>
        </p:grpSpPr>
        <p:grpSp>
          <p:nvGrpSpPr>
            <p:cNvPr id="42" name=""/>
            <p:cNvGrpSpPr/>
            <p:nvPr/>
          </p:nvGrpSpPr>
          <p:grpSpPr>
            <a:xfrm>
              <a:off x="690480" y="179280"/>
              <a:ext cx="5811840" cy="8382240"/>
              <a:chOff x="690480" y="179280"/>
              <a:chExt cx="5811840" cy="8382240"/>
            </a:xfrm>
          </p:grpSpPr>
          <p:grpSp>
            <p:nvGrpSpPr>
              <p:cNvPr id="43" name=""/>
              <p:cNvGrpSpPr/>
              <p:nvPr/>
            </p:nvGrpSpPr>
            <p:grpSpPr>
              <a:xfrm>
                <a:off x="690480" y="179280"/>
                <a:ext cx="5811840" cy="8382240"/>
                <a:chOff x="690480" y="179280"/>
                <a:chExt cx="5811840" cy="8382240"/>
              </a:xfrm>
            </p:grpSpPr>
            <p:pic>
              <p:nvPicPr>
                <p:cNvPr id="44" name="" descr=""/>
                <p:cNvPicPr/>
                <p:nvPr/>
              </p:nvPicPr>
              <p:blipFill>
                <a:blip r:embed="rId1"/>
                <a:stretch/>
              </p:blipFill>
              <p:spPr>
                <a:xfrm>
                  <a:off x="690480" y="179280"/>
                  <a:ext cx="5811840" cy="83822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45" name=""/>
                <p:cNvSpPr/>
                <p:nvPr/>
              </p:nvSpPr>
              <p:spPr>
                <a:xfrm>
                  <a:off x="765000" y="4500720"/>
                  <a:ext cx="360360" cy="122364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46" name=""/>
              <p:cNvGrpSpPr/>
              <p:nvPr/>
            </p:nvGrpSpPr>
            <p:grpSpPr>
              <a:xfrm>
                <a:off x="907920" y="1116000"/>
                <a:ext cx="652680" cy="431280"/>
                <a:chOff x="907920" y="1116000"/>
                <a:chExt cx="652680" cy="431280"/>
              </a:xfrm>
            </p:grpSpPr>
            <p:sp>
              <p:nvSpPr>
                <p:cNvPr id="47" name=""/>
                <p:cNvSpPr/>
                <p:nvPr/>
              </p:nvSpPr>
              <p:spPr>
                <a:xfrm rot="20311800">
                  <a:off x="924120" y="1328040"/>
                  <a:ext cx="644400" cy="7128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24480" bIns="244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" name=""/>
                <p:cNvSpPr/>
                <p:nvPr/>
              </p:nvSpPr>
              <p:spPr>
                <a:xfrm>
                  <a:off x="907920" y="1331640"/>
                  <a:ext cx="73080" cy="21564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" name=""/>
                <p:cNvSpPr/>
                <p:nvPr/>
              </p:nvSpPr>
              <p:spPr>
                <a:xfrm>
                  <a:off x="1487520" y="1116000"/>
                  <a:ext cx="73080" cy="21564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0" name=""/>
              <p:cNvGrpSpPr/>
              <p:nvPr/>
            </p:nvGrpSpPr>
            <p:grpSpPr>
              <a:xfrm>
                <a:off x="907920" y="5580000"/>
                <a:ext cx="652680" cy="432000"/>
                <a:chOff x="907920" y="5580000"/>
                <a:chExt cx="652680" cy="432000"/>
              </a:xfrm>
            </p:grpSpPr>
            <p:sp>
              <p:nvSpPr>
                <p:cNvPr id="51" name=""/>
                <p:cNvSpPr/>
                <p:nvPr/>
              </p:nvSpPr>
              <p:spPr>
                <a:xfrm rot="20311800">
                  <a:off x="924120" y="5792400"/>
                  <a:ext cx="644400" cy="7164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24840" bIns="2484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" name=""/>
                <p:cNvSpPr/>
                <p:nvPr/>
              </p:nvSpPr>
              <p:spPr>
                <a:xfrm>
                  <a:off x="907920" y="5796000"/>
                  <a:ext cx="73080" cy="21600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" name=""/>
                <p:cNvSpPr/>
                <p:nvPr/>
              </p:nvSpPr>
              <p:spPr>
                <a:xfrm>
                  <a:off x="1487520" y="5580000"/>
                  <a:ext cx="73080" cy="21600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4" name=""/>
              <p:cNvGrpSpPr/>
              <p:nvPr/>
            </p:nvGrpSpPr>
            <p:grpSpPr>
              <a:xfrm>
                <a:off x="704880" y="4468680"/>
                <a:ext cx="649080" cy="1311480"/>
                <a:chOff x="704880" y="4468680"/>
                <a:chExt cx="649080" cy="1311480"/>
              </a:xfrm>
            </p:grpSpPr>
            <p:sp>
              <p:nvSpPr>
                <p:cNvPr id="55" name=""/>
                <p:cNvSpPr/>
                <p:nvPr/>
              </p:nvSpPr>
              <p:spPr>
                <a:xfrm>
                  <a:off x="704880" y="5533920"/>
                  <a:ext cx="64764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624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910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" name=""/>
                <p:cNvSpPr/>
                <p:nvPr/>
              </p:nvSpPr>
              <p:spPr>
                <a:xfrm>
                  <a:off x="704880" y="5008680"/>
                  <a:ext cx="64764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624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912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" name=""/>
                <p:cNvSpPr/>
                <p:nvPr/>
              </p:nvSpPr>
              <p:spPr>
                <a:xfrm>
                  <a:off x="704880" y="4468680"/>
                  <a:ext cx="6490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624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914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58" name=""/>
              <p:cNvSpPr/>
              <p:nvPr/>
            </p:nvSpPr>
            <p:spPr>
              <a:xfrm>
                <a:off x="1197000" y="395280"/>
                <a:ext cx="1224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Pool 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1197000" y="4551480"/>
                <a:ext cx="1224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Pool B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60" name=""/>
              <p:cNvGrpSpPr/>
              <p:nvPr/>
            </p:nvGrpSpPr>
            <p:grpSpPr>
              <a:xfrm>
                <a:off x="1916280" y="5219640"/>
                <a:ext cx="433080" cy="289080"/>
                <a:chOff x="1916280" y="5219640"/>
                <a:chExt cx="433080" cy="289080"/>
              </a:xfrm>
            </p:grpSpPr>
            <p:sp>
              <p:nvSpPr>
                <p:cNvPr id="61" name=""/>
                <p:cNvSpPr/>
                <p:nvPr/>
              </p:nvSpPr>
              <p:spPr>
                <a:xfrm rot="20311800">
                  <a:off x="1924200" y="5362200"/>
                  <a:ext cx="353880" cy="4752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20" bIns="72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" name=""/>
                <p:cNvSpPr/>
                <p:nvPr/>
              </p:nvSpPr>
              <p:spPr>
                <a:xfrm>
                  <a:off x="1916280" y="5364000"/>
                  <a:ext cx="39600" cy="14472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" name=""/>
                <p:cNvSpPr/>
                <p:nvPr/>
              </p:nvSpPr>
              <p:spPr>
                <a:xfrm>
                  <a:off x="2233440" y="5219640"/>
                  <a:ext cx="115920" cy="14436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64" name=""/>
              <p:cNvGrpSpPr/>
              <p:nvPr/>
            </p:nvGrpSpPr>
            <p:grpSpPr>
              <a:xfrm>
                <a:off x="1916280" y="1042920"/>
                <a:ext cx="433080" cy="289080"/>
                <a:chOff x="1916280" y="1042920"/>
                <a:chExt cx="433080" cy="289080"/>
              </a:xfrm>
            </p:grpSpPr>
            <p:sp>
              <p:nvSpPr>
                <p:cNvPr id="65" name=""/>
                <p:cNvSpPr/>
                <p:nvPr/>
              </p:nvSpPr>
              <p:spPr>
                <a:xfrm rot="20311800">
                  <a:off x="1924200" y="1185480"/>
                  <a:ext cx="353880" cy="4752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20" bIns="72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" name=""/>
                <p:cNvSpPr/>
                <p:nvPr/>
              </p:nvSpPr>
              <p:spPr>
                <a:xfrm>
                  <a:off x="1916280" y="1187280"/>
                  <a:ext cx="39600" cy="14472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" name=""/>
                <p:cNvSpPr/>
                <p:nvPr/>
              </p:nvSpPr>
              <p:spPr>
                <a:xfrm>
                  <a:off x="2233440" y="1042920"/>
                  <a:ext cx="115920" cy="14436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68" name=""/>
              <p:cNvSpPr/>
              <p:nvPr/>
            </p:nvSpPr>
            <p:spPr>
              <a:xfrm>
                <a:off x="1700280" y="611280"/>
                <a:ext cx="360360" cy="5047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1700280" y="4788000"/>
                <a:ext cx="360360" cy="5047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70" name=""/>
              <p:cNvGrpSpPr/>
              <p:nvPr/>
            </p:nvGrpSpPr>
            <p:grpSpPr>
              <a:xfrm>
                <a:off x="1700280" y="4753080"/>
                <a:ext cx="647640" cy="576000"/>
                <a:chOff x="1700280" y="4753080"/>
                <a:chExt cx="647640" cy="576000"/>
              </a:xfrm>
            </p:grpSpPr>
            <p:sp>
              <p:nvSpPr>
                <p:cNvPr id="71" name=""/>
                <p:cNvSpPr/>
                <p:nvPr/>
              </p:nvSpPr>
              <p:spPr>
                <a:xfrm>
                  <a:off x="1700280" y="5113440"/>
                  <a:ext cx="6476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600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" name=""/>
                <p:cNvSpPr/>
                <p:nvPr/>
              </p:nvSpPr>
              <p:spPr>
                <a:xfrm>
                  <a:off x="1700280" y="4753080"/>
                  <a:ext cx="6476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650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73" name=""/>
              <p:cNvGrpSpPr/>
              <p:nvPr/>
            </p:nvGrpSpPr>
            <p:grpSpPr>
              <a:xfrm>
                <a:off x="1700280" y="563400"/>
                <a:ext cx="647640" cy="576000"/>
                <a:chOff x="1700280" y="563400"/>
                <a:chExt cx="647640" cy="576000"/>
              </a:xfrm>
            </p:grpSpPr>
            <p:sp>
              <p:nvSpPr>
                <p:cNvPr id="74" name=""/>
                <p:cNvSpPr/>
                <p:nvPr/>
              </p:nvSpPr>
              <p:spPr>
                <a:xfrm>
                  <a:off x="1700280" y="923760"/>
                  <a:ext cx="6476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750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" name=""/>
                <p:cNvSpPr/>
                <p:nvPr/>
              </p:nvSpPr>
              <p:spPr>
                <a:xfrm>
                  <a:off x="1700280" y="563400"/>
                  <a:ext cx="6476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800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76" name=""/>
            <p:cNvGrpSpPr/>
            <p:nvPr/>
          </p:nvGrpSpPr>
          <p:grpSpPr>
            <a:xfrm>
              <a:off x="596880" y="287280"/>
              <a:ext cx="647640" cy="1038600"/>
              <a:chOff x="596880" y="287280"/>
              <a:chExt cx="647640" cy="1038600"/>
            </a:xfrm>
          </p:grpSpPr>
          <p:sp>
            <p:nvSpPr>
              <p:cNvPr id="77" name=""/>
              <p:cNvSpPr/>
              <p:nvPr/>
            </p:nvSpPr>
            <p:spPr>
              <a:xfrm>
                <a:off x="728640" y="306360"/>
                <a:ext cx="360360" cy="10080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596880" y="1079640"/>
                <a:ext cx="647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0 22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596880" y="690480"/>
                <a:ext cx="647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0 24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596880" y="287280"/>
                <a:ext cx="647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0 26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1" name=""/>
            <p:cNvSpPr/>
            <p:nvPr/>
          </p:nvSpPr>
          <p:spPr>
            <a:xfrm>
              <a:off x="1808280" y="3995640"/>
              <a:ext cx="4033800" cy="30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Number of sequences obtained for each variant (N</a:t>
              </a:r>
              <a:r>
                <a:rPr b="0" lang="fr-FR" sz="1200" spc="-1" strike="noStrike" baseline="-25000">
                  <a:solidFill>
                    <a:srgbClr val="000000"/>
                  </a:solidFill>
                  <a:latin typeface="Arial"/>
                </a:rPr>
                <a:t>j</a:t>
              </a: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 rot="16200000">
              <a:off x="-715320" y="1733400"/>
              <a:ext cx="2520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Number of individual variants (</a:t>
              </a:r>
              <a:r>
                <a:rPr b="0" i="1" lang="fr-FR" sz="12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 rot="16200000">
              <a:off x="-680040" y="6089760"/>
              <a:ext cx="2449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Number of individual variants (</a:t>
              </a:r>
              <a:r>
                <a:rPr b="0" i="1" lang="fr-FR" sz="12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1808280" y="8172360"/>
              <a:ext cx="4033800" cy="30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Number of sequences obtained for each variant (N</a:t>
              </a:r>
              <a:r>
                <a:rPr b="0" lang="fr-FR" sz="1200" spc="-1" strike="noStrike" baseline="-25000">
                  <a:solidFill>
                    <a:srgbClr val="000000"/>
                  </a:solidFill>
                  <a:latin typeface="Arial"/>
                </a:rPr>
                <a:t>j</a:t>
              </a: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5" name=""/>
          <p:cNvSpPr/>
          <p:nvPr/>
        </p:nvSpPr>
        <p:spPr>
          <a:xfrm>
            <a:off x="0" y="8604360"/>
            <a:ext cx="141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Fig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6" name=""/>
          <p:cNvGrpSpPr/>
          <p:nvPr/>
        </p:nvGrpSpPr>
        <p:grpSpPr>
          <a:xfrm>
            <a:off x="871560" y="468360"/>
            <a:ext cx="5078520" cy="7795440"/>
            <a:chOff x="871560" y="468360"/>
            <a:chExt cx="5078520" cy="7795440"/>
          </a:xfrm>
        </p:grpSpPr>
        <p:pic>
          <p:nvPicPr>
            <p:cNvPr id="87" name="" descr=""/>
            <p:cNvPicPr/>
            <p:nvPr/>
          </p:nvPicPr>
          <p:blipFill>
            <a:blip r:embed="rId1"/>
            <a:srcRect l="3780" t="8485" r="13076" b="3382"/>
            <a:stretch/>
          </p:blipFill>
          <p:spPr>
            <a:xfrm>
              <a:off x="1197000" y="468360"/>
              <a:ext cx="4753080" cy="7488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8" name=""/>
            <p:cNvSpPr/>
            <p:nvPr/>
          </p:nvSpPr>
          <p:spPr>
            <a:xfrm>
              <a:off x="2023920" y="3708360"/>
              <a:ext cx="3527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Number of sequences (</a:t>
              </a:r>
              <a:r>
                <a:rPr b="0" i="1" lang="fr-FR" sz="1400" spc="-1" strike="noStrike">
                  <a:solidFill>
                    <a:srgbClr val="000000"/>
                  </a:solidFill>
                  <a:latin typeface="Arial"/>
                </a:rPr>
                <a:t>Ni</a:t>
              </a: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2025720" y="7956720"/>
              <a:ext cx="35272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Number of sequences (</a:t>
              </a:r>
              <a:r>
                <a:rPr b="0" i="1" lang="fr-FR" sz="1400" spc="-1" strike="noStrike">
                  <a:solidFill>
                    <a:srgbClr val="000000"/>
                  </a:solidFill>
                  <a:latin typeface="Arial"/>
                </a:rPr>
                <a:t>Ni</a:t>
              </a: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 rot="16200000">
              <a:off x="-270000" y="1752840"/>
              <a:ext cx="25905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Number of samples (</a:t>
              </a:r>
              <a:r>
                <a:rPr b="0" i="1" lang="fr-FR" sz="14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 rot="16200000">
              <a:off x="-268560" y="6000840"/>
              <a:ext cx="259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Number of samples (</a:t>
              </a:r>
              <a:r>
                <a:rPr b="0" i="1" lang="fr-FR" sz="14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2817720" y="468360"/>
              <a:ext cx="18734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Pool 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2816280" y="4643280"/>
              <a:ext cx="1873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Pool B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4" name=""/>
          <p:cNvSpPr/>
          <p:nvPr/>
        </p:nvSpPr>
        <p:spPr>
          <a:xfrm>
            <a:off x="0" y="8604360"/>
            <a:ext cx="141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Fig S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"/>
          <p:cNvSpPr/>
          <p:nvPr/>
        </p:nvSpPr>
        <p:spPr>
          <a:xfrm>
            <a:off x="0" y="8604360"/>
            <a:ext cx="141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Fig S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6" name=""/>
          <p:cNvGrpSpPr/>
          <p:nvPr/>
        </p:nvGrpSpPr>
        <p:grpSpPr>
          <a:xfrm>
            <a:off x="0" y="971640"/>
            <a:ext cx="6858000" cy="5127480"/>
            <a:chOff x="0" y="971640"/>
            <a:chExt cx="6858000" cy="5127480"/>
          </a:xfrm>
        </p:grpSpPr>
        <p:grpSp>
          <p:nvGrpSpPr>
            <p:cNvPr id="97" name=""/>
            <p:cNvGrpSpPr/>
            <p:nvPr/>
          </p:nvGrpSpPr>
          <p:grpSpPr>
            <a:xfrm>
              <a:off x="0" y="971640"/>
              <a:ext cx="6858000" cy="5127480"/>
              <a:chOff x="0" y="971640"/>
              <a:chExt cx="6858000" cy="5127480"/>
            </a:xfrm>
          </p:grpSpPr>
          <p:pic>
            <p:nvPicPr>
              <p:cNvPr id="98" name="" descr=""/>
              <p:cNvPicPr/>
              <p:nvPr/>
            </p:nvPicPr>
            <p:blipFill>
              <a:blip r:embed="rId1"/>
              <a:stretch/>
            </p:blipFill>
            <p:spPr>
              <a:xfrm>
                <a:off x="0" y="971640"/>
                <a:ext cx="3308400" cy="24987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9" name="" descr=""/>
              <p:cNvPicPr/>
              <p:nvPr/>
            </p:nvPicPr>
            <p:blipFill>
              <a:blip r:embed="rId2"/>
              <a:stretch/>
            </p:blipFill>
            <p:spPr>
              <a:xfrm>
                <a:off x="3549600" y="971640"/>
                <a:ext cx="3308400" cy="24987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00" name="" descr=""/>
              <p:cNvPicPr/>
              <p:nvPr/>
            </p:nvPicPr>
            <p:blipFill>
              <a:blip r:embed="rId3"/>
              <a:stretch/>
            </p:blipFill>
            <p:spPr>
              <a:xfrm>
                <a:off x="0" y="3600360"/>
                <a:ext cx="3308400" cy="24987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01" name="" descr=""/>
              <p:cNvPicPr/>
              <p:nvPr/>
            </p:nvPicPr>
            <p:blipFill>
              <a:blip r:embed="rId4"/>
              <a:stretch/>
            </p:blipFill>
            <p:spPr>
              <a:xfrm>
                <a:off x="3549600" y="3598920"/>
                <a:ext cx="3308400" cy="2498760"/>
              </a:xfrm>
              <a:prstGeom prst="rect">
                <a:avLst/>
              </a:prstGeom>
              <a:ln w="0">
                <a:noFill/>
              </a:ln>
            </p:spPr>
          </p:pic>
        </p:grpSp>
        <p:pic>
          <p:nvPicPr>
            <p:cNvPr id="102" name="" descr=""/>
            <p:cNvPicPr/>
            <p:nvPr/>
          </p:nvPicPr>
          <p:blipFill>
            <a:blip r:embed="rId5"/>
            <a:srcRect l="5325" t="6418" r="85412" b="10348"/>
            <a:stretch/>
          </p:blipFill>
          <p:spPr>
            <a:xfrm>
              <a:off x="3716280" y="3749760"/>
              <a:ext cx="306360" cy="2095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3" name="" descr=""/>
            <p:cNvPicPr/>
            <p:nvPr/>
          </p:nvPicPr>
          <p:blipFill>
            <a:blip r:embed="rId6"/>
            <a:srcRect l="34098" t="92694" r="22734" b="0"/>
            <a:stretch/>
          </p:blipFill>
          <p:spPr>
            <a:xfrm>
              <a:off x="4724280" y="5900760"/>
              <a:ext cx="1368720" cy="176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4" name="" descr=""/>
            <p:cNvPicPr/>
            <p:nvPr/>
          </p:nvPicPr>
          <p:blipFill>
            <a:blip r:embed="rId7"/>
            <a:srcRect l="5325" t="6418" r="85412" b="10348"/>
            <a:stretch/>
          </p:blipFill>
          <p:spPr>
            <a:xfrm>
              <a:off x="3716280" y="1116000"/>
              <a:ext cx="306360" cy="2095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5" name="" descr=""/>
            <p:cNvPicPr/>
            <p:nvPr/>
          </p:nvPicPr>
          <p:blipFill>
            <a:blip r:embed="rId8"/>
            <a:srcRect l="5325" t="6418" r="85412" b="10348"/>
            <a:stretch/>
          </p:blipFill>
          <p:spPr>
            <a:xfrm>
              <a:off x="171360" y="1116000"/>
              <a:ext cx="306360" cy="2095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6" name="" descr=""/>
            <p:cNvPicPr/>
            <p:nvPr/>
          </p:nvPicPr>
          <p:blipFill>
            <a:blip r:embed="rId9"/>
            <a:srcRect l="5325" t="6418" r="85412" b="10348"/>
            <a:stretch/>
          </p:blipFill>
          <p:spPr>
            <a:xfrm>
              <a:off x="171360" y="3749760"/>
              <a:ext cx="306360" cy="2095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7" name="" descr=""/>
            <p:cNvPicPr/>
            <p:nvPr/>
          </p:nvPicPr>
          <p:blipFill>
            <a:blip r:embed="rId10"/>
            <a:srcRect l="34098" t="92694" r="22734" b="0"/>
            <a:stretch/>
          </p:blipFill>
          <p:spPr>
            <a:xfrm>
              <a:off x="1162080" y="5900760"/>
              <a:ext cx="1368360" cy="176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8" name="" descr=""/>
            <p:cNvPicPr/>
            <p:nvPr/>
          </p:nvPicPr>
          <p:blipFill>
            <a:blip r:embed="rId11"/>
            <a:srcRect l="34098" t="92694" r="22734" b="0"/>
            <a:stretch/>
          </p:blipFill>
          <p:spPr>
            <a:xfrm>
              <a:off x="1160640" y="3276720"/>
              <a:ext cx="1368360" cy="176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9" name="" descr=""/>
            <p:cNvPicPr/>
            <p:nvPr/>
          </p:nvPicPr>
          <p:blipFill>
            <a:blip r:embed="rId12"/>
            <a:srcRect l="34098" t="92694" r="22734" b="0"/>
            <a:stretch/>
          </p:blipFill>
          <p:spPr>
            <a:xfrm>
              <a:off x="4724280" y="3276720"/>
              <a:ext cx="1368720" cy="17604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0" name=""/>
          <p:cNvGrpSpPr/>
          <p:nvPr/>
        </p:nvGrpSpPr>
        <p:grpSpPr>
          <a:xfrm>
            <a:off x="260280" y="244440"/>
            <a:ext cx="6337440" cy="8060040"/>
            <a:chOff x="260280" y="244440"/>
            <a:chExt cx="6337440" cy="8060040"/>
          </a:xfrm>
        </p:grpSpPr>
        <p:grpSp>
          <p:nvGrpSpPr>
            <p:cNvPr id="111" name=""/>
            <p:cNvGrpSpPr/>
            <p:nvPr/>
          </p:nvGrpSpPr>
          <p:grpSpPr>
            <a:xfrm>
              <a:off x="549360" y="244440"/>
              <a:ext cx="6048360" cy="7856640"/>
              <a:chOff x="549360" y="244440"/>
              <a:chExt cx="6048360" cy="7856640"/>
            </a:xfrm>
          </p:grpSpPr>
          <p:pic>
            <p:nvPicPr>
              <p:cNvPr id="112" name="" descr=""/>
              <p:cNvPicPr/>
              <p:nvPr/>
            </p:nvPicPr>
            <p:blipFill>
              <a:blip r:embed="rId1"/>
              <a:srcRect l="3419" t="905" r="830" b="2696"/>
              <a:stretch/>
            </p:blipFill>
            <p:spPr>
              <a:xfrm>
                <a:off x="549360" y="324000"/>
                <a:ext cx="6048360" cy="77770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3" name="" descr=""/>
              <p:cNvPicPr/>
              <p:nvPr/>
            </p:nvPicPr>
            <p:blipFill>
              <a:blip r:embed="rId2"/>
              <a:srcRect l="21668" t="74094" r="75345" b="23245"/>
              <a:stretch/>
            </p:blipFill>
            <p:spPr>
              <a:xfrm>
                <a:off x="598320" y="1114560"/>
                <a:ext cx="189000" cy="215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4" name="" descr=""/>
              <p:cNvPicPr/>
              <p:nvPr/>
            </p:nvPicPr>
            <p:blipFill>
              <a:blip r:embed="rId3"/>
              <a:srcRect l="21234" t="79439" r="75350" b="16982"/>
              <a:stretch/>
            </p:blipFill>
            <p:spPr>
              <a:xfrm>
                <a:off x="585720" y="1860480"/>
                <a:ext cx="216000" cy="2890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5" name="" descr=""/>
              <p:cNvPicPr/>
              <p:nvPr/>
            </p:nvPicPr>
            <p:blipFill>
              <a:blip r:embed="rId4"/>
              <a:srcRect l="21234" t="85697" r="75350" b="10743"/>
              <a:stretch/>
            </p:blipFill>
            <p:spPr>
              <a:xfrm>
                <a:off x="549360" y="2738520"/>
                <a:ext cx="215640" cy="2872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6" name="" descr=""/>
              <p:cNvPicPr/>
              <p:nvPr/>
            </p:nvPicPr>
            <p:blipFill>
              <a:blip r:embed="rId5"/>
              <a:srcRect l="20848" t="91931" r="76088" b="4493"/>
              <a:stretch/>
            </p:blipFill>
            <p:spPr>
              <a:xfrm>
                <a:off x="549360" y="3616200"/>
                <a:ext cx="193680" cy="2890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7" name="" descr=""/>
              <p:cNvPicPr/>
              <p:nvPr/>
            </p:nvPicPr>
            <p:blipFill>
              <a:blip r:embed="rId6"/>
              <a:srcRect l="21668" t="67830" r="75345" b="29490"/>
              <a:stretch/>
            </p:blipFill>
            <p:spPr>
              <a:xfrm>
                <a:off x="598320" y="244440"/>
                <a:ext cx="189000" cy="21600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118" name=""/>
            <p:cNvSpPr/>
            <p:nvPr/>
          </p:nvSpPr>
          <p:spPr>
            <a:xfrm>
              <a:off x="2421000" y="3995640"/>
              <a:ext cx="2592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Forward Tag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2421000" y="8028000"/>
              <a:ext cx="2592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Reverse Tag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 rot="16200000">
              <a:off x="-969480" y="1914480"/>
              <a:ext cx="2736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% of assigned sequences within po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 rot="16200000">
              <a:off x="182520" y="5946120"/>
              <a:ext cx="2737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% of assigned sequences within po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2" name=""/>
          <p:cNvSpPr/>
          <p:nvPr/>
        </p:nvSpPr>
        <p:spPr>
          <a:xfrm>
            <a:off x="0" y="8604360"/>
            <a:ext cx="141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Fig S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8-21T08:34:45Z</dcterms:created>
  <dc:creator>max</dc:creator>
  <dc:description/>
  <dc:language>en-US</dc:language>
  <cp:lastModifiedBy>max</cp:lastModifiedBy>
  <dcterms:modified xsi:type="dcterms:W3CDTF">2010-04-29T13:14:20Z</dcterms:modified>
  <cp:revision>28</cp:revision>
  <dc:subject/>
  <dc:title>Diapositive 1</dc:title>
</cp:coreProperties>
</file>